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0" r:id="rId2"/>
  </p:sldIdLst>
  <p:sldSz cx="9144000" cy="6858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CFB7C"/>
    <a:srgbClr val="D63C85"/>
    <a:srgbClr val="C852C6"/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386"/>
    <p:restoredTop sz="91830" autoAdjust="0"/>
  </p:normalViewPr>
  <p:slideViewPr>
    <p:cSldViewPr snapToGrid="0" snapToObjects="1">
      <p:cViewPr varScale="1">
        <p:scale>
          <a:sx n="101" d="100"/>
          <a:sy n="101" d="100"/>
        </p:scale>
        <p:origin x="2478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jessicaliu\Dropbox\WD\GBB_Genome_selection\R_used\Output_ANOVA_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jessicaliu\Dropbox\WD\GBB_Genome_selection\R_used\Output_ANOVA_summary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jessicaliu\Dropbox\WD\GBB_Genome_selection\R_used\Output_ANOVA_summar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58251113823199"/>
          <c:y val="0.13169050192075599"/>
          <c:w val="0.82110112383761402"/>
          <c:h val="0.67999061314317799"/>
        </c:manualLayout>
      </c:layout>
      <c:barChart>
        <c:barDir val="col"/>
        <c:grouping val="clustered"/>
        <c:varyColors val="0"/>
        <c:ser>
          <c:idx val="0"/>
          <c:order val="0"/>
          <c:tx>
            <c:v>X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26GFL_effect'!$N$9:$V$9</c:f>
                <c:numCache>
                  <c:formatCode>General</c:formatCode>
                  <c:ptCount val="9"/>
                  <c:pt idx="0">
                    <c:v>4.0010977205251303E-3</c:v>
                  </c:pt>
                  <c:pt idx="1">
                    <c:v>5.29015796390495E-3</c:v>
                  </c:pt>
                  <c:pt idx="2">
                    <c:v>3.7399901326111398E-3</c:v>
                  </c:pt>
                  <c:pt idx="3">
                    <c:v>6.8590410418406496E-3</c:v>
                  </c:pt>
                  <c:pt idx="4">
                    <c:v>2.51701202747397E-3</c:v>
                  </c:pt>
                  <c:pt idx="5">
                    <c:v>8.0138008834958006E-3</c:v>
                  </c:pt>
                  <c:pt idx="6">
                    <c:v>3.2789344877778501E-3</c:v>
                  </c:pt>
                  <c:pt idx="7">
                    <c:v>9.9992743323244499E-3</c:v>
                  </c:pt>
                  <c:pt idx="8">
                    <c:v>3.3347353212373498E-3</c:v>
                  </c:pt>
                </c:numCache>
              </c:numRef>
            </c:plus>
            <c:minus>
              <c:numRef>
                <c:f>'226GFL_effect'!$N$9:$V$9</c:f>
                <c:numCache>
                  <c:formatCode>General</c:formatCode>
                  <c:ptCount val="9"/>
                  <c:pt idx="0">
                    <c:v>4.0010977205251303E-3</c:v>
                  </c:pt>
                  <c:pt idx="1">
                    <c:v>5.29015796390495E-3</c:v>
                  </c:pt>
                  <c:pt idx="2">
                    <c:v>3.7399901326111398E-3</c:v>
                  </c:pt>
                  <c:pt idx="3">
                    <c:v>6.8590410418406496E-3</c:v>
                  </c:pt>
                  <c:pt idx="4">
                    <c:v>2.51701202747397E-3</c:v>
                  </c:pt>
                  <c:pt idx="5">
                    <c:v>8.0138008834958006E-3</c:v>
                  </c:pt>
                  <c:pt idx="6">
                    <c:v>3.2789344877778501E-3</c:v>
                  </c:pt>
                  <c:pt idx="7">
                    <c:v>9.9992743323244499E-3</c:v>
                  </c:pt>
                  <c:pt idx="8">
                    <c:v>3.33473532123734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6GFL_effect'!$C$1:$K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226GFL_effect'!$C$2:$K$2</c:f>
              <c:numCache>
                <c:formatCode>General</c:formatCode>
                <c:ptCount val="9"/>
                <c:pt idx="0">
                  <c:v>0.79044931771828997</c:v>
                </c:pt>
                <c:pt idx="1">
                  <c:v>0.77747809642676202</c:v>
                </c:pt>
                <c:pt idx="2">
                  <c:v>0.79288463467626202</c:v>
                </c:pt>
                <c:pt idx="3">
                  <c:v>0.71790817470032398</c:v>
                </c:pt>
                <c:pt idx="4">
                  <c:v>0.81617063053116101</c:v>
                </c:pt>
                <c:pt idx="5">
                  <c:v>0.63580029261037496</c:v>
                </c:pt>
                <c:pt idx="6">
                  <c:v>0.80432748325482994</c:v>
                </c:pt>
                <c:pt idx="7">
                  <c:v>0.64070370495743001</c:v>
                </c:pt>
                <c:pt idx="8">
                  <c:v>0.80444358232583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8D-47DB-ACFD-9F460AE03D79}"/>
            </c:ext>
          </c:extLst>
        </c:ser>
        <c:ser>
          <c:idx val="1"/>
          <c:order val="1"/>
          <c:tx>
            <c:v>Y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26GFL_effect'!$N$10:$V$10</c:f>
                <c:numCache>
                  <c:formatCode>General</c:formatCode>
                  <c:ptCount val="9"/>
                  <c:pt idx="0">
                    <c:v>3.8761112754868501E-3</c:v>
                  </c:pt>
                  <c:pt idx="1">
                    <c:v>3.4964878060580701E-3</c:v>
                  </c:pt>
                  <c:pt idx="2">
                    <c:v>4.2251269496358101E-3</c:v>
                  </c:pt>
                  <c:pt idx="3">
                    <c:v>7.7559283925616E-3</c:v>
                  </c:pt>
                  <c:pt idx="4">
                    <c:v>2.9243275065418801E-3</c:v>
                  </c:pt>
                  <c:pt idx="5">
                    <c:v>1.11492281410808E-2</c:v>
                  </c:pt>
                  <c:pt idx="6">
                    <c:v>3.5169296114974202E-3</c:v>
                  </c:pt>
                  <c:pt idx="7">
                    <c:v>7.6416265218494997E-3</c:v>
                  </c:pt>
                  <c:pt idx="8">
                    <c:v>2.6585357807863601E-3</c:v>
                  </c:pt>
                </c:numCache>
              </c:numRef>
            </c:plus>
            <c:minus>
              <c:numRef>
                <c:f>'226GFL_effect'!$N$10:$V$10</c:f>
                <c:numCache>
                  <c:formatCode>General</c:formatCode>
                  <c:ptCount val="9"/>
                  <c:pt idx="0">
                    <c:v>3.8761112754868501E-3</c:v>
                  </c:pt>
                  <c:pt idx="1">
                    <c:v>3.4964878060580701E-3</c:v>
                  </c:pt>
                  <c:pt idx="2">
                    <c:v>4.2251269496358101E-3</c:v>
                  </c:pt>
                  <c:pt idx="3">
                    <c:v>7.7559283925616E-3</c:v>
                  </c:pt>
                  <c:pt idx="4">
                    <c:v>2.9243275065418801E-3</c:v>
                  </c:pt>
                  <c:pt idx="5">
                    <c:v>1.11492281410808E-2</c:v>
                  </c:pt>
                  <c:pt idx="6">
                    <c:v>3.5169296114974202E-3</c:v>
                  </c:pt>
                  <c:pt idx="7">
                    <c:v>7.6416265218494997E-3</c:v>
                  </c:pt>
                  <c:pt idx="8">
                    <c:v>2.65853578078636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6GFL_effect'!$C$1:$K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226GFL_effect'!$C$3:$K$3</c:f>
              <c:numCache>
                <c:formatCode>General</c:formatCode>
                <c:ptCount val="9"/>
                <c:pt idx="0">
                  <c:v>0.77240573686435599</c:v>
                </c:pt>
                <c:pt idx="1">
                  <c:v>0.76058824955614401</c:v>
                </c:pt>
                <c:pt idx="2">
                  <c:v>0.77465216651613</c:v>
                </c:pt>
                <c:pt idx="3">
                  <c:v>0.70303992814716398</c:v>
                </c:pt>
                <c:pt idx="4">
                  <c:v>0.80293245009221303</c:v>
                </c:pt>
                <c:pt idx="5">
                  <c:v>0.60912326294658103</c:v>
                </c:pt>
                <c:pt idx="6">
                  <c:v>0.78792484149313902</c:v>
                </c:pt>
                <c:pt idx="7">
                  <c:v>0.51973854557725696</c:v>
                </c:pt>
                <c:pt idx="8">
                  <c:v>0.782400543695496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8D-47DB-ACFD-9F460AE03D79}"/>
            </c:ext>
          </c:extLst>
        </c:ser>
        <c:ser>
          <c:idx val="2"/>
          <c:order val="2"/>
          <c:tx>
            <c:v>Z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26GFL_effect'!$N$11:$V$11</c:f>
                <c:numCache>
                  <c:formatCode>General</c:formatCode>
                  <c:ptCount val="9"/>
                  <c:pt idx="0">
                    <c:v>5.9204701405804498E-3</c:v>
                  </c:pt>
                  <c:pt idx="1">
                    <c:v>5.9972698767370002E-3</c:v>
                  </c:pt>
                  <c:pt idx="2">
                    <c:v>6.00867488982055E-3</c:v>
                  </c:pt>
                  <c:pt idx="3">
                    <c:v>8.7642800459018008E-3</c:v>
                  </c:pt>
                  <c:pt idx="4">
                    <c:v>6.6699215140836E-3</c:v>
                  </c:pt>
                  <c:pt idx="5">
                    <c:v>1.2320906412550601E-2</c:v>
                  </c:pt>
                  <c:pt idx="6">
                    <c:v>7.0055783967797004E-3</c:v>
                  </c:pt>
                  <c:pt idx="7">
                    <c:v>1.7140376377439401E-2</c:v>
                  </c:pt>
                  <c:pt idx="8">
                    <c:v>6.5959884548330997E-3</c:v>
                  </c:pt>
                </c:numCache>
              </c:numRef>
            </c:plus>
            <c:minus>
              <c:numRef>
                <c:f>'226GFL_effect'!$N$11:$V$11</c:f>
                <c:numCache>
                  <c:formatCode>General</c:formatCode>
                  <c:ptCount val="9"/>
                  <c:pt idx="0">
                    <c:v>5.9204701405804498E-3</c:v>
                  </c:pt>
                  <c:pt idx="1">
                    <c:v>5.9972698767370002E-3</c:v>
                  </c:pt>
                  <c:pt idx="2">
                    <c:v>6.00867488982055E-3</c:v>
                  </c:pt>
                  <c:pt idx="3">
                    <c:v>8.7642800459018008E-3</c:v>
                  </c:pt>
                  <c:pt idx="4">
                    <c:v>6.6699215140836E-3</c:v>
                  </c:pt>
                  <c:pt idx="5">
                    <c:v>1.2320906412550601E-2</c:v>
                  </c:pt>
                  <c:pt idx="6">
                    <c:v>7.0055783967797004E-3</c:v>
                  </c:pt>
                  <c:pt idx="7">
                    <c:v>1.7140376377439401E-2</c:v>
                  </c:pt>
                  <c:pt idx="8">
                    <c:v>6.595988454833099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6GFL_effect'!$C$1:$K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226GFL_effect'!$C$4:$K$4</c:f>
              <c:numCache>
                <c:formatCode>General</c:formatCode>
                <c:ptCount val="9"/>
                <c:pt idx="0">
                  <c:v>0.54579900926983405</c:v>
                </c:pt>
                <c:pt idx="1">
                  <c:v>0.50990815174352</c:v>
                </c:pt>
                <c:pt idx="2">
                  <c:v>0.56635434630083503</c:v>
                </c:pt>
                <c:pt idx="3">
                  <c:v>0.38905803194767402</c:v>
                </c:pt>
                <c:pt idx="4">
                  <c:v>0.57781392561029998</c:v>
                </c:pt>
                <c:pt idx="5">
                  <c:v>0.36224846701487001</c:v>
                </c:pt>
                <c:pt idx="6">
                  <c:v>0.55553194411912599</c:v>
                </c:pt>
                <c:pt idx="7">
                  <c:v>0.35520395168340002</c:v>
                </c:pt>
                <c:pt idx="8">
                  <c:v>0.52538554773679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78D-47DB-ACFD-9F460AE03D79}"/>
            </c:ext>
          </c:extLst>
        </c:ser>
        <c:ser>
          <c:idx val="3"/>
          <c:order val="3"/>
          <c:tx>
            <c:v>W</c:v>
          </c:tx>
          <c:spPr>
            <a:solidFill>
              <a:srgbClr val="008F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26GFL_effect'!$N$13:$V$13</c:f>
                <c:numCache>
                  <c:formatCode>General</c:formatCode>
                  <c:ptCount val="9"/>
                  <c:pt idx="0">
                    <c:v>5.1192782029292503E-3</c:v>
                  </c:pt>
                  <c:pt idx="1">
                    <c:v>5.1700894938130999E-3</c:v>
                  </c:pt>
                  <c:pt idx="2">
                    <c:v>5.6434775113465502E-3</c:v>
                  </c:pt>
                  <c:pt idx="3">
                    <c:v>8.3853950262005508E-3</c:v>
                  </c:pt>
                  <c:pt idx="4">
                    <c:v>3.1286361439129599E-3</c:v>
                  </c:pt>
                  <c:pt idx="5">
                    <c:v>8.9678368169906E-3</c:v>
                  </c:pt>
                  <c:pt idx="6">
                    <c:v>3.7146800126383098E-3</c:v>
                  </c:pt>
                  <c:pt idx="7">
                    <c:v>9.9581884357376003E-3</c:v>
                  </c:pt>
                  <c:pt idx="8">
                    <c:v>3.7568103267761901E-3</c:v>
                  </c:pt>
                </c:numCache>
              </c:numRef>
            </c:plus>
            <c:minus>
              <c:numRef>
                <c:f>'226GFL_effect'!$N$13:$V$13</c:f>
                <c:numCache>
                  <c:formatCode>General</c:formatCode>
                  <c:ptCount val="9"/>
                  <c:pt idx="0">
                    <c:v>5.1192782029292503E-3</c:v>
                  </c:pt>
                  <c:pt idx="1">
                    <c:v>5.1700894938130999E-3</c:v>
                  </c:pt>
                  <c:pt idx="2">
                    <c:v>5.6434775113465502E-3</c:v>
                  </c:pt>
                  <c:pt idx="3">
                    <c:v>8.3853950262005508E-3</c:v>
                  </c:pt>
                  <c:pt idx="4">
                    <c:v>3.1286361439129599E-3</c:v>
                  </c:pt>
                  <c:pt idx="5">
                    <c:v>8.9678368169906E-3</c:v>
                  </c:pt>
                  <c:pt idx="6">
                    <c:v>3.7146800126383098E-3</c:v>
                  </c:pt>
                  <c:pt idx="7">
                    <c:v>9.9581884357376003E-3</c:v>
                  </c:pt>
                  <c:pt idx="8">
                    <c:v>3.75681032677619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6GFL_effect'!$C$1:$K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226GFL_effect'!$C$6:$K$6</c:f>
              <c:numCache>
                <c:formatCode>General</c:formatCode>
                <c:ptCount val="9"/>
                <c:pt idx="0">
                  <c:v>0.71001113446653197</c:v>
                </c:pt>
                <c:pt idx="1">
                  <c:v>0.68964121949652402</c:v>
                </c:pt>
                <c:pt idx="2">
                  <c:v>0.70797240326278499</c:v>
                </c:pt>
                <c:pt idx="3">
                  <c:v>0.63780063283201305</c:v>
                </c:pt>
                <c:pt idx="4">
                  <c:v>0.72720119092941804</c:v>
                </c:pt>
                <c:pt idx="5">
                  <c:v>0.47524166005324697</c:v>
                </c:pt>
                <c:pt idx="6">
                  <c:v>0.71590909370439904</c:v>
                </c:pt>
                <c:pt idx="7">
                  <c:v>0.59712586138860402</c:v>
                </c:pt>
                <c:pt idx="8">
                  <c:v>0.70089312598584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78D-47DB-ACFD-9F460AE03D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overlap val="-27"/>
        <c:axId val="190347640"/>
        <c:axId val="190351560"/>
      </c:barChart>
      <c:catAx>
        <c:axId val="190347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" charset="0"/>
                <a:ea typeface="Times" charset="0"/>
                <a:cs typeface="Times" charset="0"/>
              </a:defRPr>
            </a:pPr>
            <a:endParaRPr lang="en-US"/>
          </a:p>
        </c:txPr>
        <c:crossAx val="190351560"/>
        <c:crosses val="autoZero"/>
        <c:auto val="1"/>
        <c:lblAlgn val="ctr"/>
        <c:lblOffset val="100"/>
        <c:noMultiLvlLbl val="0"/>
      </c:catAx>
      <c:valAx>
        <c:axId val="190351560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" charset="0"/>
                    <a:ea typeface="Times" charset="0"/>
                    <a:cs typeface="Times" charset="0"/>
                  </a:defRPr>
                </a:pPr>
                <a:r>
                  <a:rPr lang="en-US" sz="800" b="0" dirty="0"/>
                  <a:t>Prediction accuracy</a:t>
                </a:r>
                <a:r>
                  <a:rPr lang="en-US" sz="800" b="0" baseline="0" dirty="0"/>
                  <a:t> (</a:t>
                </a:r>
                <a:r>
                  <a:rPr lang="en-US" sz="800" b="0" i="1" baseline="0" dirty="0"/>
                  <a:t>r</a:t>
                </a:r>
                <a:r>
                  <a:rPr lang="en-US" sz="800" b="0" baseline="0" dirty="0"/>
                  <a:t>) </a:t>
                </a:r>
                <a:endParaRPr lang="en-US" sz="800" b="0" dirty="0"/>
              </a:p>
            </c:rich>
          </c:tx>
          <c:layout>
            <c:manualLayout>
              <c:xMode val="edge"/>
              <c:yMode val="edge"/>
              <c:x val="1.7384576928166747E-2"/>
              <c:y val="0.303610390225047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Times" charset="0"/>
                  <a:ea typeface="Times" charset="0"/>
                  <a:cs typeface="Times" charset="0"/>
                </a:defRPr>
              </a:pPr>
              <a:endParaRPr lang="en-US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" charset="0"/>
                <a:ea typeface="Times" charset="0"/>
                <a:cs typeface="Times" charset="0"/>
              </a:defRPr>
            </a:pPr>
            <a:endParaRPr lang="en-US"/>
          </a:p>
        </c:txPr>
        <c:crossAx val="190347640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58389500484665"/>
          <c:y val="6.0107436125988997E-2"/>
          <c:w val="0.31108367656444003"/>
          <c:h val="7.158306579476700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/>
              </a:solidFill>
              <a:latin typeface="Times" charset="0"/>
              <a:ea typeface="Times" charset="0"/>
              <a:cs typeface="Times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" charset="0"/>
          <a:ea typeface="Times" charset="0"/>
          <a:cs typeface="Times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5516136855043"/>
          <c:y val="8.9944604150038202E-2"/>
          <c:w val="0.75266012113248604"/>
          <c:h val="0.70576129817935596"/>
        </c:manualLayout>
      </c:layout>
      <c:barChart>
        <c:barDir val="col"/>
        <c:grouping val="clustered"/>
        <c:varyColors val="0"/>
        <c:ser>
          <c:idx val="0"/>
          <c:order val="0"/>
          <c:tx>
            <c:v>I</c:v>
          </c:tx>
          <c:spPr>
            <a:solidFill>
              <a:srgbClr val="C852C6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19G_edgeff_expr'!$M$7:$U$7</c:f>
                <c:numCache>
                  <c:formatCode>General</c:formatCode>
                  <c:ptCount val="9"/>
                  <c:pt idx="0">
                    <c:v>9.0212755809005504E-3</c:v>
                  </c:pt>
                  <c:pt idx="1">
                    <c:v>1.3202805499999999E-2</c:v>
                  </c:pt>
                  <c:pt idx="2">
                    <c:v>9.56897991634445E-3</c:v>
                  </c:pt>
                  <c:pt idx="3">
                    <c:v>1.0989973E-2</c:v>
                  </c:pt>
                  <c:pt idx="4">
                    <c:v>9.9995453167532507E-3</c:v>
                  </c:pt>
                  <c:pt idx="5">
                    <c:v>8.8676840000000007E-3</c:v>
                  </c:pt>
                  <c:pt idx="6">
                    <c:v>8.0269036480658008E-3</c:v>
                  </c:pt>
                  <c:pt idx="7">
                    <c:v>1.1651379861895E-2</c:v>
                  </c:pt>
                  <c:pt idx="8">
                    <c:v>8.1245297679127006E-3</c:v>
                  </c:pt>
                </c:numCache>
              </c:numRef>
            </c:plus>
            <c:minus>
              <c:numRef>
                <c:f>'19G_edgeff_expr'!$M$7:$U$7</c:f>
                <c:numCache>
                  <c:formatCode>General</c:formatCode>
                  <c:ptCount val="9"/>
                  <c:pt idx="0">
                    <c:v>9.0212755809005504E-3</c:v>
                  </c:pt>
                  <c:pt idx="1">
                    <c:v>1.3202805499999999E-2</c:v>
                  </c:pt>
                  <c:pt idx="2">
                    <c:v>9.56897991634445E-3</c:v>
                  </c:pt>
                  <c:pt idx="3">
                    <c:v>1.0989973E-2</c:v>
                  </c:pt>
                  <c:pt idx="4">
                    <c:v>9.9995453167532507E-3</c:v>
                  </c:pt>
                  <c:pt idx="5">
                    <c:v>8.8676840000000007E-3</c:v>
                  </c:pt>
                  <c:pt idx="6">
                    <c:v>8.0269036480658008E-3</c:v>
                  </c:pt>
                  <c:pt idx="7">
                    <c:v>1.1651379861895E-2</c:v>
                  </c:pt>
                  <c:pt idx="8">
                    <c:v>8.1245297679127006E-3</c:v>
                  </c:pt>
                </c:numCache>
              </c:numRef>
            </c:minus>
          </c:errBars>
          <c:cat>
            <c:strRef>
              <c:f>'19G_edgeff_expr'!$B$1:$J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19G_edgeff_expr'!$B$2:$J$2</c:f>
              <c:numCache>
                <c:formatCode>General</c:formatCode>
                <c:ptCount val="9"/>
                <c:pt idx="0">
                  <c:v>0.426874107669727</c:v>
                </c:pt>
                <c:pt idx="1">
                  <c:v>0.405520777</c:v>
                </c:pt>
                <c:pt idx="2">
                  <c:v>0.42872752633163602</c:v>
                </c:pt>
                <c:pt idx="3">
                  <c:v>0.41504227100000002</c:v>
                </c:pt>
                <c:pt idx="4">
                  <c:v>0.41086840937889402</c:v>
                </c:pt>
                <c:pt idx="5">
                  <c:v>0.36097415500000002</c:v>
                </c:pt>
                <c:pt idx="6">
                  <c:v>0.44069771334922198</c:v>
                </c:pt>
                <c:pt idx="7">
                  <c:v>0.37212882321452101</c:v>
                </c:pt>
                <c:pt idx="8">
                  <c:v>0.39609677627297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7E-4F94-8CF0-C0FDCE0DEC89}"/>
            </c:ext>
          </c:extLst>
        </c:ser>
        <c:ser>
          <c:idx val="1"/>
          <c:order val="1"/>
          <c:tx>
            <c:v>II</c:v>
          </c:tx>
          <c:spPr>
            <a:solidFill>
              <a:schemeClr val="accent6">
                <a:lumMod val="60000"/>
                <a:lumOff val="40000"/>
              </a:schemeClr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19G_edgeff_expr'!$M$8:$U$8</c:f>
                <c:numCache>
                  <c:formatCode>General</c:formatCode>
                  <c:ptCount val="9"/>
                  <c:pt idx="0">
                    <c:v>9.9684395875564002E-3</c:v>
                  </c:pt>
                  <c:pt idx="1">
                    <c:v>1.0344519E-2</c:v>
                  </c:pt>
                  <c:pt idx="2">
                    <c:v>8.8510561170234495E-3</c:v>
                  </c:pt>
                  <c:pt idx="3">
                    <c:v>1.0054837E-2</c:v>
                  </c:pt>
                  <c:pt idx="4">
                    <c:v>5.2457285390772497E-3</c:v>
                  </c:pt>
                  <c:pt idx="5">
                    <c:v>1.3082812500000001E-2</c:v>
                  </c:pt>
                  <c:pt idx="6">
                    <c:v>8.0847924734307498E-3</c:v>
                  </c:pt>
                  <c:pt idx="7">
                    <c:v>1.69550146595637E-2</c:v>
                  </c:pt>
                  <c:pt idx="8">
                    <c:v>1.15893035115748E-2</c:v>
                  </c:pt>
                </c:numCache>
              </c:numRef>
            </c:plus>
            <c:minus>
              <c:numRef>
                <c:f>'19G_edgeff_expr'!$M$8:$U$8</c:f>
                <c:numCache>
                  <c:formatCode>General</c:formatCode>
                  <c:ptCount val="9"/>
                  <c:pt idx="0">
                    <c:v>9.9684395875564002E-3</c:v>
                  </c:pt>
                  <c:pt idx="1">
                    <c:v>1.0344519E-2</c:v>
                  </c:pt>
                  <c:pt idx="2">
                    <c:v>8.8510561170234495E-3</c:v>
                  </c:pt>
                  <c:pt idx="3">
                    <c:v>1.0054837E-2</c:v>
                  </c:pt>
                  <c:pt idx="4">
                    <c:v>5.2457285390772497E-3</c:v>
                  </c:pt>
                  <c:pt idx="5">
                    <c:v>1.3082812500000001E-2</c:v>
                  </c:pt>
                  <c:pt idx="6">
                    <c:v>8.0847924734307498E-3</c:v>
                  </c:pt>
                  <c:pt idx="7">
                    <c:v>1.69550146595637E-2</c:v>
                  </c:pt>
                  <c:pt idx="8">
                    <c:v>1.15893035115748E-2</c:v>
                  </c:pt>
                </c:numCache>
              </c:numRef>
            </c:minus>
          </c:errBars>
          <c:cat>
            <c:strRef>
              <c:f>'19G_edgeff_expr'!$B$1:$J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19G_edgeff_expr'!$B$3:$J$3</c:f>
              <c:numCache>
                <c:formatCode>General</c:formatCode>
                <c:ptCount val="9"/>
                <c:pt idx="0">
                  <c:v>0.36378772010739302</c:v>
                </c:pt>
                <c:pt idx="1">
                  <c:v>0.34086881299999999</c:v>
                </c:pt>
                <c:pt idx="2">
                  <c:v>0.37083918255190101</c:v>
                </c:pt>
                <c:pt idx="3">
                  <c:v>0.351492476</c:v>
                </c:pt>
                <c:pt idx="4">
                  <c:v>0.39125613566809597</c:v>
                </c:pt>
                <c:pt idx="5">
                  <c:v>0.33449300999999998</c:v>
                </c:pt>
                <c:pt idx="6">
                  <c:v>0.36758778289989502</c:v>
                </c:pt>
                <c:pt idx="7">
                  <c:v>0.28241935311111399</c:v>
                </c:pt>
                <c:pt idx="8">
                  <c:v>0.3407052314874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7E-4F94-8CF0-C0FDCE0DEC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axId val="190350776"/>
        <c:axId val="190351168"/>
      </c:barChart>
      <c:catAx>
        <c:axId val="1903507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>
                <a:lumMod val="50000"/>
                <a:lumOff val="50000"/>
              </a:schemeClr>
            </a:solidFill>
          </a:ln>
        </c:spPr>
        <c:txPr>
          <a:bodyPr/>
          <a:lstStyle/>
          <a:p>
            <a:pPr>
              <a:defRPr sz="700">
                <a:solidFill>
                  <a:schemeClr val="tx1"/>
                </a:solidFill>
              </a:defRPr>
            </a:pPr>
            <a:endParaRPr lang="en-US"/>
          </a:p>
        </c:txPr>
        <c:crossAx val="190351168"/>
        <c:crosses val="autoZero"/>
        <c:auto val="1"/>
        <c:lblAlgn val="ctr"/>
        <c:lblOffset val="100"/>
        <c:noMultiLvlLbl val="0"/>
      </c:catAx>
      <c:valAx>
        <c:axId val="190351168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defRPr sz="800" b="0"/>
                </a:pPr>
                <a:r>
                  <a:rPr lang="en-US" sz="800" b="0" dirty="0"/>
                  <a:t>Prediction</a:t>
                </a:r>
                <a:r>
                  <a:rPr lang="en-US" sz="800" b="0" baseline="0" dirty="0"/>
                  <a:t> accuracy (</a:t>
                </a:r>
                <a:r>
                  <a:rPr lang="en-US" sz="800" b="0" i="1" baseline="0" dirty="0"/>
                  <a:t>r</a:t>
                </a:r>
                <a:r>
                  <a:rPr lang="en-US" sz="800" b="0" baseline="0" dirty="0"/>
                  <a:t>) </a:t>
                </a:r>
                <a:endParaRPr lang="en-US" sz="800" b="0" dirty="0"/>
              </a:p>
            </c:rich>
          </c:tx>
          <c:layout>
            <c:manualLayout>
              <c:xMode val="edge"/>
              <c:yMode val="edge"/>
              <c:x val="1.0711668995438997E-2"/>
              <c:y val="0.27160303966502669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chemeClr val="tx1">
                <a:lumMod val="50000"/>
                <a:lumOff val="50000"/>
              </a:schemeClr>
            </a:solidFill>
          </a:ln>
        </c:spPr>
        <c:txPr>
          <a:bodyPr/>
          <a:lstStyle/>
          <a:p>
            <a:pPr>
              <a:defRPr sz="700"/>
            </a:pPr>
            <a:endParaRPr lang="en-US"/>
          </a:p>
        </c:txPr>
        <c:crossAx val="190350776"/>
        <c:crosses val="autoZero"/>
        <c:crossBetween val="between"/>
        <c:majorUnit val="0.2"/>
      </c:valAx>
      <c:spPr>
        <a:ln>
          <a:solidFill>
            <a:schemeClr val="tx1">
              <a:lumMod val="50000"/>
              <a:lumOff val="50000"/>
            </a:schemeClr>
          </a:solidFill>
        </a:ln>
      </c:spPr>
    </c:plotArea>
    <c:legend>
      <c:legendPos val="t"/>
      <c:layout>
        <c:manualLayout>
          <c:xMode val="edge"/>
          <c:yMode val="edge"/>
          <c:x val="0.42357920957392098"/>
          <c:y val="1.22515460438797E-3"/>
          <c:w val="0.27258618498293602"/>
          <c:h val="8.7633380123743096E-2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solidFill>
            <a:schemeClr val="tx1"/>
          </a:solidFill>
          <a:latin typeface="Times" charset="0"/>
          <a:ea typeface="Times" charset="0"/>
          <a:cs typeface="Times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8870723304859"/>
          <c:y val="0.10051872347436779"/>
          <c:w val="0.83201225217844099"/>
          <c:h val="0.63951691864241789"/>
        </c:manualLayout>
      </c:layout>
      <c:barChart>
        <c:barDir val="col"/>
        <c:grouping val="clustered"/>
        <c:varyColors val="0"/>
        <c:ser>
          <c:idx val="0"/>
          <c:order val="0"/>
          <c:tx>
            <c:v>I</c:v>
          </c:tx>
          <c:spPr>
            <a:solidFill>
              <a:srgbClr val="6CFB7C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26GFL_expr_genotype'!$M$8:$U$8</c:f>
                <c:numCache>
                  <c:formatCode>General</c:formatCode>
                  <c:ptCount val="9"/>
                  <c:pt idx="0">
                    <c:v>5.1047446647790604E-3</c:v>
                  </c:pt>
                  <c:pt idx="1">
                    <c:v>6.2846394782774904E-3</c:v>
                  </c:pt>
                  <c:pt idx="2">
                    <c:v>5.70809553732461E-3</c:v>
                  </c:pt>
                  <c:pt idx="3">
                    <c:v>7.9541814778975092E-3</c:v>
                  </c:pt>
                  <c:pt idx="4">
                    <c:v>6.03161441382333E-3</c:v>
                  </c:pt>
                  <c:pt idx="5">
                    <c:v>8.4480558381826304E-3</c:v>
                  </c:pt>
                  <c:pt idx="6">
                    <c:v>2.43026295896078E-3</c:v>
                  </c:pt>
                  <c:pt idx="7">
                    <c:v>9.7153941372152396E-3</c:v>
                  </c:pt>
                  <c:pt idx="8">
                    <c:v>3.6629845017526102E-3</c:v>
                  </c:pt>
                </c:numCache>
              </c:numRef>
            </c:plus>
            <c:minus>
              <c:numRef>
                <c:f>'226GFL_expr_genotype'!$M$8:$U$8</c:f>
                <c:numCache>
                  <c:formatCode>General</c:formatCode>
                  <c:ptCount val="9"/>
                  <c:pt idx="0">
                    <c:v>5.1047446647790604E-3</c:v>
                  </c:pt>
                  <c:pt idx="1">
                    <c:v>6.2846394782774904E-3</c:v>
                  </c:pt>
                  <c:pt idx="2">
                    <c:v>5.70809553732461E-3</c:v>
                  </c:pt>
                  <c:pt idx="3">
                    <c:v>7.9541814778975092E-3</c:v>
                  </c:pt>
                  <c:pt idx="4">
                    <c:v>6.03161441382333E-3</c:v>
                  </c:pt>
                  <c:pt idx="5">
                    <c:v>8.4480558381826304E-3</c:v>
                  </c:pt>
                  <c:pt idx="6">
                    <c:v>2.43026295896078E-3</c:v>
                  </c:pt>
                  <c:pt idx="7">
                    <c:v>9.7153941372152396E-3</c:v>
                  </c:pt>
                  <c:pt idx="8">
                    <c:v>3.662984501752610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6GFL_expr_genotype'!$B$1:$J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226GFL_expr_genotype'!$B$3:$J$3</c:f>
              <c:numCache>
                <c:formatCode>0.00</c:formatCode>
                <c:ptCount val="9"/>
                <c:pt idx="0">
                  <c:v>0.68717214469038301</c:v>
                </c:pt>
                <c:pt idx="1">
                  <c:v>0.67326732941290202</c:v>
                </c:pt>
                <c:pt idx="2">
                  <c:v>0.681198737425736</c:v>
                </c:pt>
                <c:pt idx="3">
                  <c:v>0.60562343887830505</c:v>
                </c:pt>
                <c:pt idx="4">
                  <c:v>0.70504263028097902</c:v>
                </c:pt>
                <c:pt idx="5">
                  <c:v>0.47483726515109698</c:v>
                </c:pt>
                <c:pt idx="6">
                  <c:v>0.69261746572117899</c:v>
                </c:pt>
                <c:pt idx="7">
                  <c:v>0.457616812183677</c:v>
                </c:pt>
                <c:pt idx="8">
                  <c:v>0.692192429846102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41-4390-952A-88E165F0D467}"/>
            </c:ext>
          </c:extLst>
        </c:ser>
        <c:ser>
          <c:idx val="1"/>
          <c:order val="1"/>
          <c:tx>
            <c:v>II</c:v>
          </c:tx>
          <c:spPr>
            <a:solidFill>
              <a:srgbClr val="D63C8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26GFL_expr_genotype'!$M$9:$U$9</c:f>
                <c:numCache>
                  <c:formatCode>General</c:formatCode>
                  <c:ptCount val="9"/>
                  <c:pt idx="0">
                    <c:v>3.7591346653522602E-3</c:v>
                  </c:pt>
                  <c:pt idx="1">
                    <c:v>5.6572102666712799E-3</c:v>
                  </c:pt>
                  <c:pt idx="2">
                    <c:v>4.4973412131889302E-3</c:v>
                  </c:pt>
                  <c:pt idx="3">
                    <c:v>7.2111253903552304E-3</c:v>
                  </c:pt>
                  <c:pt idx="4">
                    <c:v>3.67860624019285E-3</c:v>
                  </c:pt>
                  <c:pt idx="5">
                    <c:v>5.71548937084104E-3</c:v>
                  </c:pt>
                  <c:pt idx="6">
                    <c:v>4.2856207077388003E-3</c:v>
                  </c:pt>
                  <c:pt idx="7">
                    <c:v>1.8863183987527499E-2</c:v>
                  </c:pt>
                  <c:pt idx="8">
                    <c:v>3.38745702956505E-3</c:v>
                  </c:pt>
                </c:numCache>
              </c:numRef>
            </c:plus>
            <c:minus>
              <c:numRef>
                <c:f>'226GFL_expr_genotype'!$M$9:$U$9</c:f>
                <c:numCache>
                  <c:formatCode>General</c:formatCode>
                  <c:ptCount val="9"/>
                  <c:pt idx="0">
                    <c:v>3.7591346653522602E-3</c:v>
                  </c:pt>
                  <c:pt idx="1">
                    <c:v>5.6572102666712799E-3</c:v>
                  </c:pt>
                  <c:pt idx="2">
                    <c:v>4.4973412131889302E-3</c:v>
                  </c:pt>
                  <c:pt idx="3">
                    <c:v>7.2111253903552304E-3</c:v>
                  </c:pt>
                  <c:pt idx="4">
                    <c:v>3.67860624019285E-3</c:v>
                  </c:pt>
                  <c:pt idx="5">
                    <c:v>5.71548937084104E-3</c:v>
                  </c:pt>
                  <c:pt idx="6">
                    <c:v>4.2856207077388003E-3</c:v>
                  </c:pt>
                  <c:pt idx="7">
                    <c:v>1.8863183987527499E-2</c:v>
                  </c:pt>
                  <c:pt idx="8">
                    <c:v>3.38745702956505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26GFL_expr_genotype'!$B$1:$J$1</c:f>
              <c:strCache>
                <c:ptCount val="9"/>
                <c:pt idx="0">
                  <c:v>BayesA</c:v>
                </c:pt>
                <c:pt idx="1">
                  <c:v>BayesB</c:v>
                </c:pt>
                <c:pt idx="2">
                  <c:v>GBLUP</c:v>
                </c:pt>
                <c:pt idx="3">
                  <c:v>LASSO</c:v>
                </c:pt>
                <c:pt idx="4">
                  <c:v>PLS</c:v>
                </c:pt>
                <c:pt idx="5">
                  <c:v>RF</c:v>
                </c:pt>
                <c:pt idx="6">
                  <c:v>RKHS</c:v>
                </c:pt>
                <c:pt idx="7">
                  <c:v>SVMPOLY</c:v>
                </c:pt>
                <c:pt idx="8">
                  <c:v>SVMRBF</c:v>
                </c:pt>
              </c:strCache>
            </c:strRef>
          </c:cat>
          <c:val>
            <c:numRef>
              <c:f>'226GFL_expr_genotype'!$B$4:$J$4</c:f>
              <c:numCache>
                <c:formatCode>0.00</c:formatCode>
                <c:ptCount val="9"/>
                <c:pt idx="0">
                  <c:v>0.70789386820131395</c:v>
                </c:pt>
                <c:pt idx="1">
                  <c:v>0.70636410208995404</c:v>
                </c:pt>
                <c:pt idx="2">
                  <c:v>0.69390444504934301</c:v>
                </c:pt>
                <c:pt idx="3">
                  <c:v>0.69712228893834904</c:v>
                </c:pt>
                <c:pt idx="4">
                  <c:v>0.73089336906182201</c:v>
                </c:pt>
                <c:pt idx="5">
                  <c:v>0.51651575903275604</c:v>
                </c:pt>
                <c:pt idx="6">
                  <c:v>0.71082402831022895</c:v>
                </c:pt>
                <c:pt idx="7">
                  <c:v>0.46595870200039902</c:v>
                </c:pt>
                <c:pt idx="8">
                  <c:v>0.70540702319425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41-4390-952A-88E165F0D4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0352344"/>
        <c:axId val="190352736"/>
      </c:barChart>
      <c:catAx>
        <c:axId val="190352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endParaRPr lang="en-US"/>
          </a:p>
        </c:txPr>
        <c:crossAx val="190352736"/>
        <c:crosses val="autoZero"/>
        <c:auto val="1"/>
        <c:lblAlgn val="ctr"/>
        <c:lblOffset val="100"/>
        <c:noMultiLvlLbl val="0"/>
      </c:catAx>
      <c:valAx>
        <c:axId val="190352736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Times New Roman" charset="0"/>
                    <a:ea typeface="Times New Roman" charset="0"/>
                    <a:cs typeface="Times New Roman" charset="0"/>
                  </a:defRPr>
                </a:pPr>
                <a:r>
                  <a:rPr lang="en-US" dirty="0"/>
                  <a:t>Prediction accuracy</a:t>
                </a:r>
                <a:r>
                  <a:rPr lang="en-US" baseline="0" dirty="0"/>
                  <a:t> (</a:t>
                </a:r>
                <a:r>
                  <a:rPr lang="en-US" i="1" baseline="0" dirty="0"/>
                  <a:t>r</a:t>
                </a:r>
                <a:r>
                  <a:rPr lang="en-US" baseline="0" dirty="0"/>
                  <a:t>)</a:t>
                </a:r>
                <a:endParaRPr 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Times New Roman" charset="0"/>
                  <a:ea typeface="Times New Roman" charset="0"/>
                  <a:cs typeface="Times New Roman" charset="0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endParaRPr lang="en-US"/>
          </a:p>
        </c:txPr>
        <c:crossAx val="190352344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36915592138029824"/>
          <c:y val="2.8336808534412065E-2"/>
          <c:w val="0.34241416086021448"/>
          <c:h val="7.93902821229117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Times New Roman" charset="0"/>
          <a:ea typeface="Times New Roman" charset="0"/>
          <a:cs typeface="Times New Roman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6733" cy="469780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008705" y="0"/>
            <a:ext cx="3066733" cy="469780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r">
              <a:defRPr sz="1200"/>
            </a:lvl1pPr>
          </a:lstStyle>
          <a:p>
            <a:fld id="{3C9F68CD-90C4-7748-8CEA-A390B91AC6E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93297"/>
            <a:ext cx="3066733" cy="469779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008705" y="8893297"/>
            <a:ext cx="3066733" cy="469779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r">
              <a:defRPr sz="1200"/>
            </a:lvl1pPr>
          </a:lstStyle>
          <a:p>
            <a:fld id="{ADBFDD35-CC67-FC44-BD99-08DD78BBA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6568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6733" cy="469780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08705" y="0"/>
            <a:ext cx="3066733" cy="469780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r">
              <a:defRPr sz="1200"/>
            </a:lvl1pPr>
          </a:lstStyle>
          <a:p>
            <a:fld id="{A9E4DEA8-D882-B641-883F-47F659727EB0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69988"/>
            <a:ext cx="4213225" cy="31607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936" tIns="46968" rIns="93936" bIns="4696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7708" y="4505980"/>
            <a:ext cx="5661660" cy="3686711"/>
          </a:xfrm>
          <a:prstGeom prst="rect">
            <a:avLst/>
          </a:prstGeom>
        </p:spPr>
        <p:txBody>
          <a:bodyPr vert="horz" lIns="93936" tIns="46968" rIns="93936" bIns="4696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93297"/>
            <a:ext cx="3066733" cy="469779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08705" y="8893297"/>
            <a:ext cx="3066733" cy="469779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r">
              <a:defRPr sz="1200"/>
            </a:lvl1pPr>
          </a:lstStyle>
          <a:p>
            <a:fld id="{0B138FEA-BD44-E842-97FF-1F7DD025F3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558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138FEA-BD44-E842-97FF-1F7DD025F3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8022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02201-B76E-984E-B12B-F18840886DDF}" type="datetimeFigureOut">
              <a:rPr lang="en-US" smtClean="0"/>
              <a:t>7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4EBCF-DBD0-ED4C-AF3F-2426BBCC57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961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66762" y="4994521"/>
            <a:ext cx="8497685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FIGURE S2.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Selection of key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for GBB. The selection was performed based on their roles in the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network, their contributions to fiber length and their SNP/</a:t>
            </a:r>
            <a:r>
              <a:rPr lang="en-US" sz="10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InDe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mutations. Gene expression profiles were used for the prediction. Different letters, significant at CI ≥ 95%; same letter, not significant at CI ≥ 95%; error bar, standard deviation for 10 replications. 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(A)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Prediction accuracy of fiber length with the 19 network-edge key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(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Supplementary Table S1B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). I, The 19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that had edge number variation in the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network significantly influencing fiber length; II, 19 randomly-selected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. (B)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Prediction accuracy of fiber length with the 226 SNP/</a:t>
            </a:r>
            <a:r>
              <a:rPr lang="en-US" sz="10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InDe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-containing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(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Supplementary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Table S1C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). I, The 226 SNP/</a:t>
            </a:r>
            <a:r>
              <a:rPr lang="en-US" sz="10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InDe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-containing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; II, 226 randomly-selected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enes. 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(C) 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Prediction accuracy of fiber length using a subset of 226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enes selected according to their effects on fiber length (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Supplementary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Table S1A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). X, a subset of 226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consisting of all 54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having the positive effects, 59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having the smallest negative effects and 113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having the largest negative effects on fiber length; Y, a subset of 226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consisting of all 54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enes having the positive effects and 172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enes having the smallest negative effects on fiber length; W, 226 randomly-selected 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FL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genes; Z, a subset of 226</a:t>
            </a:r>
            <a:r>
              <a:rPr lang="en-US" sz="1000" i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FL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</a:rPr>
              <a:t> genes having the largest negative effects on fiber length. </a:t>
            </a:r>
            <a:endParaRPr lang="en-US" sz="10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D948E7F-1526-4332-A514-ED31AD0A34D4}"/>
              </a:ext>
            </a:extLst>
          </p:cNvPr>
          <p:cNvGrpSpPr/>
          <p:nvPr/>
        </p:nvGrpSpPr>
        <p:grpSpPr>
          <a:xfrm>
            <a:off x="1541762" y="33844"/>
            <a:ext cx="5428255" cy="4970006"/>
            <a:chOff x="1541762" y="33844"/>
            <a:chExt cx="5428255" cy="497000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135725F-F1FB-4B87-ABCB-30520A83FEE2}"/>
                </a:ext>
              </a:extLst>
            </p:cNvPr>
            <p:cNvGrpSpPr/>
            <p:nvPr/>
          </p:nvGrpSpPr>
          <p:grpSpPr>
            <a:xfrm>
              <a:off x="2558145" y="2393952"/>
              <a:ext cx="3536468" cy="2609898"/>
              <a:chOff x="3764390" y="-74588"/>
              <a:chExt cx="3536468" cy="2609898"/>
            </a:xfrm>
          </p:grpSpPr>
          <p:graphicFrame>
            <p:nvGraphicFramePr>
              <p:cNvPr id="32" name="Chart 3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56759100"/>
                  </p:ext>
                </p:extLst>
              </p:nvPr>
            </p:nvGraphicFramePr>
            <p:xfrm>
              <a:off x="3764390" y="-74588"/>
              <a:ext cx="3536468" cy="253546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" name="TextBox 12"/>
              <p:cNvSpPr txBox="1"/>
              <p:nvPr/>
            </p:nvSpPr>
            <p:spPr>
              <a:xfrm>
                <a:off x="4179253" y="13132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" charset="0"/>
                    <a:ea typeface="Times" charset="0"/>
                    <a:cs typeface="Times" charset="0"/>
                  </a:rPr>
                  <a:t>C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011843" y="2319866"/>
                <a:ext cx="92845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ediction models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4133583" y="316328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4203969" y="31989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4277131" y="31851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4347517" y="318460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461343" y="318771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531729" y="31612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4597517" y="31403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4669057" y="316340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4776712" y="318473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4847098" y="32088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4912886" y="31674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4990646" y="316038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094393" y="314426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165987" y="31684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5243003" y="316093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306015" y="318867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419841" y="317353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482853" y="31696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5556015" y="31557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5633775" y="314370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5741381" y="320623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5811767" y="31681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5883775" y="31979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5955315" y="317883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6067461" y="318845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6137847" y="31504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6211009" y="321030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6281395" y="313605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6382283" y="315564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6458889" y="315164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6524677" y="32094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6602437" y="31909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6716991" y="318847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6780003" y="31504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6846945" y="31801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6924705" y="316363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1541762" y="33844"/>
              <a:ext cx="2437622" cy="2513093"/>
              <a:chOff x="187980" y="570944"/>
              <a:chExt cx="2437622" cy="2513093"/>
            </a:xfrm>
          </p:grpSpPr>
          <p:graphicFrame>
            <p:nvGraphicFramePr>
              <p:cNvPr id="30" name="Chart 2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87982427"/>
                  </p:ext>
                </p:extLst>
              </p:nvPr>
            </p:nvGraphicFramePr>
            <p:xfrm>
              <a:off x="187980" y="605243"/>
              <a:ext cx="2437622" cy="240592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5" name="TextBox 24"/>
              <p:cNvSpPr txBox="1"/>
              <p:nvPr/>
            </p:nvSpPr>
            <p:spPr>
              <a:xfrm>
                <a:off x="961630" y="2868593"/>
                <a:ext cx="92845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ediction models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562411" y="907386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646391" y="90703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779664" y="906929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863644" y="90807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976608" y="908111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048148" y="912414"/>
                <a:ext cx="22000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181071" y="899288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258555" y="90326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385837" y="901188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463597" y="900188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590603" y="898077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662143" y="901644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1792911" y="899847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870671" y="900390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995219" y="898439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072979" y="900587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2203747" y="897172"/>
                <a:ext cx="2343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2275287" y="90163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565425" y="570944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Times" charset="0"/>
                    <a:ea typeface="Times" charset="0"/>
                    <a:cs typeface="Times" charset="0"/>
                  </a:rPr>
                  <a:t>A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0097ED83-1DF2-45E4-AB7B-62E3E6E1DF68}"/>
                </a:ext>
              </a:extLst>
            </p:cNvPr>
            <p:cNvGrpSpPr/>
            <p:nvPr/>
          </p:nvGrpSpPr>
          <p:grpSpPr>
            <a:xfrm>
              <a:off x="3937861" y="33844"/>
              <a:ext cx="3032156" cy="2640135"/>
              <a:chOff x="2957644" y="2493066"/>
              <a:chExt cx="3032156" cy="2640135"/>
            </a:xfrm>
          </p:grpSpPr>
          <p:graphicFrame>
            <p:nvGraphicFramePr>
              <p:cNvPr id="83" name="Chart 8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76493161"/>
                  </p:ext>
                </p:extLst>
              </p:nvPr>
            </p:nvGraphicFramePr>
            <p:xfrm>
              <a:off x="2957644" y="2493066"/>
              <a:ext cx="2997671" cy="264013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3055CB67-B165-43BB-B28D-3DBDA7E1FD3C}"/>
                  </a:ext>
                </a:extLst>
              </p:cNvPr>
              <p:cNvGrpSpPr/>
              <p:nvPr/>
            </p:nvGrpSpPr>
            <p:grpSpPr>
              <a:xfrm>
                <a:off x="3055116" y="2505731"/>
                <a:ext cx="2934684" cy="2418055"/>
                <a:chOff x="3055116" y="2505731"/>
                <a:chExt cx="2934684" cy="2418055"/>
              </a:xfrm>
            </p:grpSpPr>
            <p:sp>
              <p:nvSpPr>
                <p:cNvPr id="21" name="TextBox 20"/>
                <p:cNvSpPr txBox="1"/>
                <p:nvPr/>
              </p:nvSpPr>
              <p:spPr>
                <a:xfrm>
                  <a:off x="3055116" y="3466136"/>
                  <a:ext cx="2609443" cy="938588"/>
                </a:xfrm>
                <a:prstGeom prst="rect">
                  <a:avLst/>
                </a:prstGeom>
              </p:spPr>
              <p:txBody>
                <a:bodyPr wrap="non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800" dirty="0">
                      <a:latin typeface="Times"/>
                      <a:cs typeface="Times"/>
                    </a:rPr>
                    <a:t>  </a:t>
                  </a: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3253153" y="2728070"/>
                  <a:ext cx="27366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b  a     b  a     b  a     b   a    b   a     b   a    b   a     a   a    b  a    </a:t>
                  </a: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3265378" y="2505731"/>
                  <a:ext cx="3382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" charset="0"/>
                      <a:ea typeface="Times" charset="0"/>
                      <a:cs typeface="Times" charset="0"/>
                    </a:rPr>
                    <a:t>B</a:t>
                  </a: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4126680" y="4708342"/>
                  <a:ext cx="92845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ediction models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77777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37</TotalTime>
  <Words>380</Words>
  <Application>Microsoft Office PowerPoint</Application>
  <PresentationFormat>On-screen Show (4:3)</PresentationFormat>
  <Paragraphs>6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cotton GBB manuscript</dc:title>
  <dc:creator>ellyce Liu</dc:creator>
  <cp:lastModifiedBy>Zhang, Hongbin</cp:lastModifiedBy>
  <cp:revision>333</cp:revision>
  <cp:lastPrinted>2017-02-06T18:14:16Z</cp:lastPrinted>
  <dcterms:created xsi:type="dcterms:W3CDTF">2017-01-04T23:35:27Z</dcterms:created>
  <dcterms:modified xsi:type="dcterms:W3CDTF">2020-07-13T21:21:57Z</dcterms:modified>
</cp:coreProperties>
</file>